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136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25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1638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7252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727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493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560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44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4803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569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0040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88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F032A-74CF-47DF-A07A-ED9C723E4125}" type="datetimeFigureOut">
              <a:rPr lang="zh-CN" altLang="en-US" smtClean="0"/>
              <a:t>2018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E2B49-7C11-4DC6-A1F8-8BFB5416E4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813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320" y="510328"/>
            <a:ext cx="8608352" cy="292219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33046" y="3629464"/>
            <a:ext cx="8235626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ure </a:t>
            </a:r>
            <a:r>
              <a:rPr lang="en-US" altLang="zh-CN" b="1" dirty="0" smtClean="0"/>
              <a:t>S1 Genotyping and gene expression examination of transgenic Arabidopsis.</a:t>
            </a:r>
          </a:p>
          <a:p>
            <a:r>
              <a:rPr lang="en-US" altLang="zh-CN" dirty="0" smtClean="0"/>
              <a:t>A. Genotyping examination by PCR, primers utilized were listed in additional file 5, the PCR reaction program was 10 min at 95°C and 34 cycles amplification reaction at 94°C for 20 s, 58°C for 30 s, 72°C for 30 s and 5 min at 72°for final extension.</a:t>
            </a:r>
          </a:p>
          <a:p>
            <a:r>
              <a:rPr lang="en-US" altLang="zh-CN" dirty="0" smtClean="0"/>
              <a:t>B. Gene expression examination by semi-PCR, primers utilized were listed in </a:t>
            </a:r>
            <a:r>
              <a:rPr lang="en-US" altLang="zh-CN" dirty="0"/>
              <a:t>additional file </a:t>
            </a:r>
            <a:r>
              <a:rPr lang="en-US" altLang="zh-CN" dirty="0" smtClean="0"/>
              <a:t>5, the PCR reaction program was 10 min at 95°C and 28 cycles amplification reaction at 94°C for 20 s, 58°C for 30 s, 72°C for 30 s and 5 min at 72°for final extension.</a:t>
            </a:r>
          </a:p>
          <a:p>
            <a:endParaRPr lang="en-US" altLang="zh-CN" dirty="0" smtClean="0"/>
          </a:p>
        </p:txBody>
      </p:sp>
    </p:spTree>
    <p:extLst>
      <p:ext uri="{BB962C8B-B14F-4D97-AF65-F5344CB8AC3E}">
        <p14:creationId xmlns:p14="http://schemas.microsoft.com/office/powerpoint/2010/main" val="3333452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</TotalTime>
  <Words>118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勇锋</dc:creator>
  <cp:lastModifiedBy>王 勇锋</cp:lastModifiedBy>
  <cp:revision>9</cp:revision>
  <dcterms:created xsi:type="dcterms:W3CDTF">2018-05-24T12:38:37Z</dcterms:created>
  <dcterms:modified xsi:type="dcterms:W3CDTF">2018-11-27T09:12:21Z</dcterms:modified>
</cp:coreProperties>
</file>